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7" r:id="rId2"/>
  </p:sldIdLst>
  <p:sldSz cx="12192000" cy="16256000"/>
  <p:notesSz cx="6858000" cy="9144000"/>
  <p:defaultTextStyle>
    <a:defPPr>
      <a:defRPr lang="en-US"/>
    </a:defPPr>
    <a:lvl1pPr marL="0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1pPr>
    <a:lvl2pPr marL="812729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2pPr>
    <a:lvl3pPr marL="1625458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3pPr>
    <a:lvl4pPr marL="2438187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4pPr>
    <a:lvl5pPr marL="3250916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5pPr>
    <a:lvl6pPr marL="4063644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6pPr>
    <a:lvl7pPr marL="4876373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7pPr>
    <a:lvl8pPr marL="5689102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8pPr>
    <a:lvl9pPr marL="6501831" algn="l" defTabSz="1625458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others, Katelyn - (katelyncarothers)" initials="CK(" lastIdx="7" clrIdx="0">
    <p:extLst>
      <p:ext uri="{19B8F6BF-5375-455C-9EA6-DF929625EA0E}">
        <p15:presenceInfo xmlns:p15="http://schemas.microsoft.com/office/powerpoint/2012/main" userId="Carothers, Katelyn - (katelyncarothers)" providerId="None"/>
      </p:ext>
    </p:extLst>
  </p:cmAuthor>
  <p:cmAuthor id="2" name="Viswanathan, VK - (vkv)" initials="VV(" lastIdx="1" clrIdx="1">
    <p:extLst>
      <p:ext uri="{19B8F6BF-5375-455C-9EA6-DF929625EA0E}">
        <p15:presenceInfo xmlns:p15="http://schemas.microsoft.com/office/powerpoint/2012/main" userId="Viswanathan, VK - (vkv)" providerId="None"/>
      </p:ext>
    </p:extLst>
  </p:cmAuthor>
  <p:cmAuthor id="3" name="Andrew Clark" initials="AC" lastIdx="13" clrIdx="2">
    <p:extLst>
      <p:ext uri="{19B8F6BF-5375-455C-9EA6-DF929625EA0E}">
        <p15:presenceInfo xmlns:p15="http://schemas.microsoft.com/office/powerpoint/2012/main" userId="d837cc602894be7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CC168"/>
    <a:srgbClr val="B7B7B7"/>
    <a:srgbClr val="43682B"/>
    <a:srgbClr val="5C5C5C"/>
    <a:srgbClr val="6AAA40"/>
    <a:srgbClr val="A5A5A5"/>
    <a:srgbClr val="6289CE"/>
    <a:srgbClr val="F1975A"/>
    <a:srgbClr val="1B3A71"/>
    <a:srgbClr val="993E0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344" autoAdjust="0"/>
    <p:restoredTop sz="93831" autoAdjust="0"/>
  </p:normalViewPr>
  <p:slideViewPr>
    <p:cSldViewPr>
      <p:cViewPr varScale="1">
        <p:scale>
          <a:sx n="35" d="100"/>
          <a:sy n="35" d="100"/>
        </p:scale>
        <p:origin x="2981" y="67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3" d="100"/>
        <a:sy n="193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51EE23-5542-BD4A-B092-111EA22A2ED4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A82413-3FDC-AA46-A2C9-54D5B298CF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316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1pPr>
    <a:lvl2pPr marL="812729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2pPr>
    <a:lvl3pPr marL="1625458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3pPr>
    <a:lvl4pPr marL="2438187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4pPr>
    <a:lvl5pPr marL="3250916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5pPr>
    <a:lvl6pPr marL="4063644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6pPr>
    <a:lvl7pPr marL="4876373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7pPr>
    <a:lvl8pPr marL="5689102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8pPr>
    <a:lvl9pPr marL="6501831" algn="l" defTabSz="812729" rtl="0" eaLnBrk="1" latinLnBrk="0" hangingPunct="1">
      <a:defRPr sz="213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5049897"/>
            <a:ext cx="10363200" cy="348450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9211733"/>
            <a:ext cx="8534400" cy="415431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198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606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650998"/>
            <a:ext cx="2743200" cy="1387028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650998"/>
            <a:ext cx="8026400" cy="1387028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089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101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10445986"/>
            <a:ext cx="10363200" cy="3228622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6889990"/>
            <a:ext cx="10363200" cy="355599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927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3793070"/>
            <a:ext cx="5384800" cy="10728209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3793070"/>
            <a:ext cx="5384800" cy="10728209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364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3638786"/>
            <a:ext cx="5386917" cy="151647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5155259"/>
            <a:ext cx="5386917" cy="9366016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9" y="3638786"/>
            <a:ext cx="5389033" cy="151647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9" y="5155259"/>
            <a:ext cx="5389033" cy="9366016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487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757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57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2" y="647230"/>
            <a:ext cx="4011084" cy="2754489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647233"/>
            <a:ext cx="6815667" cy="1387404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2" y="3401722"/>
            <a:ext cx="4011084" cy="11119557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127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11379200"/>
            <a:ext cx="7315200" cy="1343379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1452504"/>
            <a:ext cx="7315200" cy="97536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12722579"/>
            <a:ext cx="7315200" cy="190782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704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650994"/>
            <a:ext cx="10972800" cy="27093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3793070"/>
            <a:ext cx="10972800" cy="107282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15066908"/>
            <a:ext cx="284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54DC5-104E-42C3-8B1B-A4B828B9B3C3}" type="datetimeFigureOut">
              <a:rPr lang="en-US" smtClean="0"/>
              <a:t>3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15066908"/>
            <a:ext cx="3860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15066908"/>
            <a:ext cx="284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B7DC9-60E1-4C5B-8C91-5DEA52131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765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70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7664882"/>
              </p:ext>
            </p:extLst>
          </p:nvPr>
        </p:nvGraphicFramePr>
        <p:xfrm>
          <a:off x="812800" y="5588003"/>
          <a:ext cx="10261600" cy="23545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32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44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84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06400">
                <a:tc>
                  <a:txBody>
                    <a:bodyPr/>
                    <a:lstStyle/>
                    <a:p>
                      <a:pPr algn="l"/>
                      <a:r>
                        <a:rPr lang="en-US" sz="1900" b="1" dirty="0"/>
                        <a:t>Primer Name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900" b="1" dirty="0"/>
                        <a:t>Sequence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/>
                        <a:t>Notes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55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F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500" dirty="0"/>
                        <a:t>GGGCAAAAGGTGTAGGAGAAA</a:t>
                      </a:r>
                    </a:p>
                  </a:txBody>
                  <a:tcPr marL="12700" marR="12700" marT="1270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loning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.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mplementation and verification of 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tants.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56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gttccccagtttttcaattc</a:t>
                      </a:r>
                      <a:endParaRPr lang="en-US" sz="1500" b="0" i="0" u="none" strike="noStrike" cap="all" baseline="0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loning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.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mplementation and verification of 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tants.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C106 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F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tcgagaaaagtggggaga</a:t>
                      </a:r>
                      <a:endParaRPr lang="en-US" sz="1500" b="0" i="0" u="none" strike="noStrike" cap="all" baseline="0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sis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pression.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107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R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cap="all" baseline="0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cttcttgcccctactcca</a:t>
                      </a:r>
                      <a:endParaRPr lang="en-US" sz="1500" b="0" i="0" u="none" strike="noStrike" cap="all" baseline="0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sis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pression.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s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T_F</a:t>
                      </a:r>
                      <a:endParaRPr lang="en-US" sz="15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500" cap="all" baseline="0" dirty="0"/>
                        <a:t>TTGAGCGATTTACTTCGGTAAAGA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sis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s </a:t>
                      </a: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pression – housekeeping gene.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4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s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T_R</a:t>
                      </a:r>
                      <a:endParaRPr lang="en-US" sz="15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500" cap="all" baseline="0" dirty="0"/>
                        <a:t>CCATCCTGTACTGGCTCACCT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sis of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s </a:t>
                      </a: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xpression – housekeeping gene.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BS universal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/>
                      <a:endParaRPr lang="en-US" sz="15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etection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of </a:t>
                      </a:r>
                      <a:r>
                        <a:rPr lang="en-US" sz="13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losTron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intron and confirmation of 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utants.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/>
                      <a:endParaRPr lang="en-US" sz="1500" dirty="0"/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04800" y="1422400"/>
            <a:ext cx="9601200" cy="28829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4267" b="1" dirty="0"/>
          </a:p>
          <a:p>
            <a:endParaRPr lang="en-US" sz="4267" b="1" dirty="0"/>
          </a:p>
          <a:p>
            <a:endParaRPr lang="en-US" b="1" dirty="0"/>
          </a:p>
          <a:p>
            <a:endParaRPr lang="en-US" b="1" dirty="0"/>
          </a:p>
          <a:p>
            <a:r>
              <a:rPr lang="en-US" b="1" dirty="0"/>
              <a:t>Table S5.  Primers and Plasmids used in this study</a:t>
            </a:r>
          </a:p>
        </p:txBody>
      </p:sp>
      <p:graphicFrame>
        <p:nvGraphicFramePr>
          <p:cNvPr id="6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3938577"/>
              </p:ext>
            </p:extLst>
          </p:nvPr>
        </p:nvGraphicFramePr>
        <p:xfrm>
          <a:off x="812800" y="8432803"/>
          <a:ext cx="10160000" cy="16179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835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3764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06400">
                <a:tc>
                  <a:txBody>
                    <a:bodyPr/>
                    <a:lstStyle/>
                    <a:p>
                      <a:pPr algn="l"/>
                      <a:r>
                        <a:rPr lang="en-US" sz="1900" b="1" dirty="0"/>
                        <a:t>Plasmid</a:t>
                      </a:r>
                      <a:r>
                        <a:rPr lang="en-US" sz="1900" b="1" baseline="0" dirty="0"/>
                        <a:t> Name</a:t>
                      </a:r>
                      <a:endParaRPr lang="en-US" sz="1900" b="1" dirty="0"/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900" b="1" dirty="0"/>
                        <a:t>Description</a:t>
                      </a:r>
                    </a:p>
                  </a:txBody>
                  <a:tcPr marL="121920" marR="121920" marT="60960" marB="6096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TL82151</a:t>
                      </a:r>
                    </a:p>
                  </a:txBody>
                  <a:tcPr marL="12700" marR="12700" marT="12700" marB="0" anchor="b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mplementation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vector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TL821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verexpression vector</a:t>
                      </a: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GemT</a:t>
                      </a: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Easy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b-cloning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vector containing the 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ene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TL82151 </a:t>
                      </a:r>
                      <a:r>
                        <a:rPr lang="en-US" sz="15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mplementation vector with </a:t>
                      </a:r>
                      <a:r>
                        <a:rPr lang="en-US" sz="13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cloned into the MCS at </a:t>
                      </a:r>
                      <a:r>
                        <a:rPr lang="en-US" sz="1300" b="0" i="1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c</a:t>
                      </a:r>
                      <a:r>
                        <a:rPr lang="en-US" sz="13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/</a:t>
                      </a:r>
                      <a:r>
                        <a:rPr lang="en-US" sz="1300" b="0" i="1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c</a:t>
                      </a:r>
                      <a:r>
                        <a:rPr lang="en-US" sz="13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I</a:t>
                      </a:r>
                      <a:endParaRPr lang="en-US" sz="13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l" fontAlgn="b"/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MTL82153</a:t>
                      </a:r>
                      <a:r>
                        <a:rPr lang="en-US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500" b="0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gL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verexpression vector with </a:t>
                      </a:r>
                      <a:r>
                        <a:rPr lang="en-US" sz="1300" b="0" i="1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igL </a:t>
                      </a:r>
                      <a:r>
                        <a:rPr lang="en-US" sz="13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loned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into the MCS at </a:t>
                      </a:r>
                      <a:r>
                        <a:rPr lang="en-US" sz="1300" b="0" i="1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ac</a:t>
                      </a:r>
                      <a:r>
                        <a:rPr lang="en-US" sz="13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/</a:t>
                      </a:r>
                      <a:r>
                        <a:rPr lang="en-US" sz="1300" b="0" i="1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co</a:t>
                      </a:r>
                      <a:r>
                        <a:rPr lang="en-US" sz="13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  <a:r>
                        <a:rPr lang="en-US" sz="13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endParaRPr lang="en-US" sz="13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2810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068</TotalTime>
  <Words>139</Words>
  <Application>Microsoft Office PowerPoint</Application>
  <PresentationFormat>Custom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</dc:creator>
  <cp:lastModifiedBy>Carothers, Katelyn - (katelyncarothers)</cp:lastModifiedBy>
  <cp:revision>650</cp:revision>
  <cp:lastPrinted>2015-09-29T20:13:51Z</cp:lastPrinted>
  <dcterms:created xsi:type="dcterms:W3CDTF">2015-05-01T23:38:02Z</dcterms:created>
  <dcterms:modified xsi:type="dcterms:W3CDTF">2022-03-10T21:30:16Z</dcterms:modified>
</cp:coreProperties>
</file>